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  <p:sldId id="307" r:id="rId3"/>
    <p:sldId id="29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21"/>
  </p:normalViewPr>
  <p:slideViewPr>
    <p:cSldViewPr snapToGrid="0">
      <p:cViewPr varScale="1">
        <p:scale>
          <a:sx n="113" d="100"/>
          <a:sy n="113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04102-E65B-02CC-B7CF-85991BF41A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E79DC8-9D62-1904-A561-BAAA2712B6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D8609E-67CA-41BE-2587-52BACEB70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8E0088-4A24-0D54-7CBC-A7AE1E917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1B1D83-4426-5812-AC8B-884630F7E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500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63513-F791-6413-02AC-7554D212EE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11330A-C4B3-66FB-A07D-60DE258953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C64E36-522B-8C22-549F-D56171E31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015244-81DA-EF78-2730-A780A8268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13838E-E624-F294-4216-D84B7411A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60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86A726-FC91-19B6-8F4E-449902D508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D18C01-1122-6D68-F3AD-3BBD0D48A2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9B29AA-874E-8FE4-9D03-B7F61C01A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4C3769-C3CE-31AD-CEEC-D570D9490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B0D5A-DF47-5F4A-08E7-BCEF3DA94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376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29774-B66C-4A6A-494D-4A2544B26D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7258A9-4C1A-2388-8B67-54E9286451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3A1E8-BBE7-B80C-0AF8-33FC6C09C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9F0B80-F318-3571-3DA6-1D30DDE64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D6A07-3A21-22BD-90D1-B2FC9914A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784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9BAE14-4506-0B74-2CD2-364436DC3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D46B73-1404-F1CF-DA69-9EE8B4EB44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AB7659-6D0D-A71D-425D-85F61D239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B02A72-3A8A-141D-99FC-130360A9D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BFA417-3E96-849B-8437-9CCD41B3C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72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F400B3-1AC0-17D3-5CCD-C005779BC2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BBCC66-39FB-C6D2-0592-A36C0A0135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64AE80-AAA1-0ACC-C8AF-F8EB4F5C7B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5E71AA-FC14-BFB4-6AE7-D01C9A29A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A4029E-A16C-C3A8-5F0B-8813DC676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353937-0121-BC44-2E3C-95A1544B3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893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86092-654A-1931-35BB-D9291E8C3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88A403-AEAA-4188-D088-2C338E7299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076B9F-A462-B1F1-7B78-9999EBB237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00E24F-C489-2B80-A1DE-8E4D23A478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635067-5138-996A-9A74-DFD69EFDBA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679DE9-07BD-EFF9-0F93-B8E312628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D50536-A55C-8ABC-39CC-0A68B7D06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87C20D-B299-3C8F-779F-C4B5C1198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225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5B70D-07B2-4B26-6D7F-B46665DE5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3BCDCD-2017-DCA5-BF13-62F24ABA1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BBAA8A-0F08-EB96-B39E-05269E6E7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B37FDA-2259-3D32-2839-051729A1D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872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5F3661-98AE-99DB-7D4A-4689558F1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A4C88C-C777-8B2D-4212-5CF195DBE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87FB26F-9BE9-5470-6273-6FC509321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348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69129A-A5D1-D4B8-6BDF-C8342475CD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A202A0-AC87-C1CF-F3B0-4CF3C63F96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8972E8-AF25-F7D2-97AC-2B6CDE5C95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8C6733-AC5D-362C-7D3B-80018DF49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AF52BA-335C-2CD5-A26F-DAA5CCD53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985F16-7EE1-651B-05F4-D8CECE105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003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CF0C0-1C99-ACD5-7D69-77BF0FCE01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0E775F-49D6-EC2F-495C-5C89B60C83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34BCF4-A718-B057-A2EF-3647BC6241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594881-8ACE-924C-4869-41D321A22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5B77E2-2B1F-BDAB-4562-D2CC8F238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F009F7-4143-BDF0-D4D9-8CE2DF175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790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82C2FB-74AD-FBFB-9709-1F0724DAC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C3BE0A-844C-5FA8-8B73-6D4C795A7F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6AFA13-7FFE-A712-C48D-70E022AD58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4BDD2-19D5-F341-9E1E-375398EC2697}" type="datetimeFigureOut">
              <a:rPr lang="en-US" smtClean="0"/>
              <a:t>12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5356C-F5EC-229B-00F2-D82807C94B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B0E71C-0703-103D-8E09-9106E66A05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8A68F-CF32-A34B-AD30-4FC39005B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093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9.tif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"/><Relationship Id="rId5" Type="http://schemas.microsoft.com/office/2007/relationships/hdphoto" Target="../media/hdphoto2.wdp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ADF1338-19E4-C848-8AE9-7CCAF9190639}"/>
              </a:ext>
            </a:extLst>
          </p:cNvPr>
          <p:cNvGrpSpPr/>
          <p:nvPr/>
        </p:nvGrpSpPr>
        <p:grpSpPr>
          <a:xfrm>
            <a:off x="1642324" y="587863"/>
            <a:ext cx="9928001" cy="4874666"/>
            <a:chOff x="1642324" y="587863"/>
            <a:chExt cx="9928001" cy="4874666"/>
          </a:xfrm>
        </p:grpSpPr>
        <p:pic>
          <p:nvPicPr>
            <p:cNvPr id="5" name="Picture 4" descr="A picture containing grass, outdoor, green, lush&#10;&#10;Description automatically generated">
              <a:extLst>
                <a:ext uri="{FF2B5EF4-FFF2-40B4-BE49-F238E27FC236}">
                  <a16:creationId xmlns:a16="http://schemas.microsoft.com/office/drawing/2014/main" id="{CA2ED696-4FF5-439D-9B38-5159A3EE7E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24947" r="24308" b="51500"/>
            <a:stretch/>
          </p:blipFill>
          <p:spPr>
            <a:xfrm>
              <a:off x="1720048" y="1735406"/>
              <a:ext cx="2221992" cy="1527759"/>
            </a:xfrm>
            <a:prstGeom prst="rect">
              <a:avLst/>
            </a:prstGeom>
          </p:spPr>
        </p:pic>
        <p:pic>
          <p:nvPicPr>
            <p:cNvPr id="7" name="Picture 6" descr="A picture containing outdoor, blue, ocean floor&#10;&#10;Description automatically generated">
              <a:extLst>
                <a:ext uri="{FF2B5EF4-FFF2-40B4-BE49-F238E27FC236}">
                  <a16:creationId xmlns:a16="http://schemas.microsoft.com/office/drawing/2014/main" id="{0314BB04-7E11-4745-8D83-125CDDC4D0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24821" r="24309" b="51500"/>
            <a:stretch/>
          </p:blipFill>
          <p:spPr>
            <a:xfrm>
              <a:off x="4019764" y="1735406"/>
              <a:ext cx="2221992" cy="1535932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7DA5B49-1BDC-43DC-9825-12BC7878EC49}"/>
                </a:ext>
              </a:extLst>
            </p:cNvPr>
            <p:cNvSpPr txBox="1"/>
            <p:nvPr/>
          </p:nvSpPr>
          <p:spPr>
            <a:xfrm>
              <a:off x="1642324" y="587863"/>
              <a:ext cx="68140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plemental Figure 1- Thymus phenotypes in FSP1-cre/SmoM2 mice</a:t>
              </a:r>
            </a:p>
          </p:txBody>
        </p:sp>
        <p:pic>
          <p:nvPicPr>
            <p:cNvPr id="6" name="Picture 2" descr="D:\Work\Results\s100A4cre smo\Thymus\thymus pics\DSC02380.JPG">
              <a:extLst>
                <a:ext uri="{FF2B5EF4-FFF2-40B4-BE49-F238E27FC236}">
                  <a16:creationId xmlns:a16="http://schemas.microsoft.com/office/drawing/2014/main" id="{386A3FD2-77D5-4269-9FF3-188A0F1E972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53" t="39024" r="41683" b="37931"/>
            <a:stretch/>
          </p:blipFill>
          <p:spPr bwMode="auto">
            <a:xfrm>
              <a:off x="1720048" y="3368553"/>
              <a:ext cx="4521708" cy="20939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4">
              <a:extLst>
                <a:ext uri="{FF2B5EF4-FFF2-40B4-BE49-F238E27FC236}">
                  <a16:creationId xmlns:a16="http://schemas.microsoft.com/office/drawing/2014/main" id="{9C87176B-B53B-45BB-AAFD-CEB1693F07C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98748" y="2168689"/>
              <a:ext cx="2399315" cy="2307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5">
              <a:extLst>
                <a:ext uri="{FF2B5EF4-FFF2-40B4-BE49-F238E27FC236}">
                  <a16:creationId xmlns:a16="http://schemas.microsoft.com/office/drawing/2014/main" id="{5FEEFEB5-962F-45FF-B022-EE48883C1E8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98063" y="2168689"/>
              <a:ext cx="2372262" cy="21889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5B287C7A-345C-4AF2-A432-B222DD53AAED}"/>
                </a:ext>
              </a:extLst>
            </p:cNvPr>
            <p:cNvCxnSpPr/>
            <p:nvPr/>
          </p:nvCxnSpPr>
          <p:spPr>
            <a:xfrm flipV="1">
              <a:off x="6653213" y="3142628"/>
              <a:ext cx="0" cy="14478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AA2CEB40-B0F4-46B2-B30F-B27B0DB68D5D}"/>
                </a:ext>
              </a:extLst>
            </p:cNvPr>
            <p:cNvCxnSpPr/>
            <p:nvPr/>
          </p:nvCxnSpPr>
          <p:spPr>
            <a:xfrm>
              <a:off x="6653213" y="4590428"/>
              <a:ext cx="1745421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03FBB21-0C3D-41C2-BB9E-86E71E2D753A}"/>
                </a:ext>
              </a:extLst>
            </p:cNvPr>
            <p:cNvSpPr txBox="1"/>
            <p:nvPr/>
          </p:nvSpPr>
          <p:spPr>
            <a:xfrm>
              <a:off x="6369321" y="2781470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368BE0B-792E-4BBA-8A86-775740A37FEA}"/>
                </a:ext>
              </a:extLst>
            </p:cNvPr>
            <p:cNvSpPr txBox="1"/>
            <p:nvPr/>
          </p:nvSpPr>
          <p:spPr>
            <a:xfrm>
              <a:off x="7612681" y="4582255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4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C5A6871-9BE8-4224-86E4-38964EC17430}"/>
                </a:ext>
              </a:extLst>
            </p:cNvPr>
            <p:cNvSpPr txBox="1"/>
            <p:nvPr/>
          </p:nvSpPr>
          <p:spPr>
            <a:xfrm>
              <a:off x="1642324" y="1442798"/>
              <a:ext cx="1691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SP1-cre/</a:t>
              </a:r>
              <a:r>
                <a:rPr lang="en-US" dirty="0" err="1"/>
                <a:t>mTmG</a:t>
              </a:r>
              <a:endParaRPr lang="en-US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3375356-EF0F-4639-ADC4-0F40D4EF788B}"/>
                </a:ext>
              </a:extLst>
            </p:cNvPr>
            <p:cNvSpPr txBox="1"/>
            <p:nvPr/>
          </p:nvSpPr>
          <p:spPr>
            <a:xfrm>
              <a:off x="3942040" y="1442798"/>
              <a:ext cx="6333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API</a:t>
              </a:r>
            </a:p>
          </p:txBody>
        </p:sp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5CE3F760-ECCB-45CD-861E-F1E7E10A2C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42324" y="3279511"/>
              <a:ext cx="1478225" cy="375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lc="http://schemas.openxmlformats.org/drawingml/2006/lockedCanvas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lc="http://schemas.openxmlformats.org/drawingml/2006/lockedCanvas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SP1</a:t>
              </a:r>
              <a:r>
                <a:rPr lang="en-US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</a:t>
              </a: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oM2</a:t>
              </a:r>
              <a:r>
                <a:rPr lang="en-US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6">
              <a:extLst>
                <a:ext uri="{FF2B5EF4-FFF2-40B4-BE49-F238E27FC236}">
                  <a16:creationId xmlns:a16="http://schemas.microsoft.com/office/drawing/2014/main" id="{869D5E62-C579-443D-AEE5-B8E09D8226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80046" y="3279511"/>
              <a:ext cx="1529778" cy="375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lc="http://schemas.openxmlformats.org/drawingml/2006/lockedCanvas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lc="http://schemas.openxmlformats.org/drawingml/2006/lockedCanvas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SP1</a:t>
              </a:r>
              <a:r>
                <a:rPr lang="en-US" kern="1200" baseline="30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oM2</a:t>
              </a:r>
              <a:r>
                <a:rPr lang="en-US" kern="1200" baseline="30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6">
              <a:extLst>
                <a:ext uri="{FF2B5EF4-FFF2-40B4-BE49-F238E27FC236}">
                  <a16:creationId xmlns:a16="http://schemas.microsoft.com/office/drawing/2014/main" id="{16BFB69F-E143-4D71-9186-AFFBCCE774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90260" y="2203941"/>
              <a:ext cx="1478225" cy="375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lc="http://schemas.openxmlformats.org/drawingml/2006/lockedCanvas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lc="http://schemas.openxmlformats.org/drawingml/2006/lockedCanvas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SP1</a:t>
              </a:r>
              <a:r>
                <a:rPr lang="en-US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-</a:t>
              </a: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oM2</a:t>
              </a:r>
              <a:r>
                <a:rPr lang="en-US" baseline="30000" dirty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6">
              <a:extLst>
                <a:ext uri="{FF2B5EF4-FFF2-40B4-BE49-F238E27FC236}">
                  <a16:creationId xmlns:a16="http://schemas.microsoft.com/office/drawing/2014/main" id="{B4D18CDE-E562-40B2-B362-9D048A9D63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427982" y="2203941"/>
              <a:ext cx="1529778" cy="375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lc="http://schemas.openxmlformats.org/drawingml/2006/lockedCanvas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lc="http://schemas.openxmlformats.org/drawingml/2006/lockedCanvas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SP1</a:t>
              </a:r>
              <a:r>
                <a:rPr lang="en-US" kern="1200" baseline="30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r>
                <a:rPr lang="en-US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oM2</a:t>
              </a:r>
              <a:r>
                <a:rPr lang="en-US" kern="1200" baseline="30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endPara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537BF89A-ED4F-E022-D502-926349567AAA}"/>
              </a:ext>
            </a:extLst>
          </p:cNvPr>
          <p:cNvSpPr txBox="1"/>
          <p:nvPr/>
        </p:nvSpPr>
        <p:spPr>
          <a:xfrm>
            <a:off x="1817511" y="1062582"/>
            <a:ext cx="633315" cy="380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E1C756-6D31-0BDD-704D-BD775C36FC51}"/>
              </a:ext>
            </a:extLst>
          </p:cNvPr>
          <p:cNvSpPr txBox="1"/>
          <p:nvPr/>
        </p:nvSpPr>
        <p:spPr>
          <a:xfrm>
            <a:off x="6469371" y="1156193"/>
            <a:ext cx="633315" cy="380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47608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E8571C7-E02F-91E3-A6A0-4F6CA7A5088E}"/>
              </a:ext>
            </a:extLst>
          </p:cNvPr>
          <p:cNvGrpSpPr/>
          <p:nvPr/>
        </p:nvGrpSpPr>
        <p:grpSpPr>
          <a:xfrm>
            <a:off x="478287" y="243361"/>
            <a:ext cx="11212449" cy="6023626"/>
            <a:chOff x="478287" y="243361"/>
            <a:chExt cx="11212449" cy="6023626"/>
          </a:xfrm>
        </p:grpSpPr>
        <p:pic>
          <p:nvPicPr>
            <p:cNvPr id="5" name="Picture 4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id="{BDBCCF84-A54D-FA38-BEFD-6FA814C659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89" t="13979" r="41169" b="45381"/>
            <a:stretch/>
          </p:blipFill>
          <p:spPr>
            <a:xfrm>
              <a:off x="537382" y="3813719"/>
              <a:ext cx="3182822" cy="2453268"/>
            </a:xfrm>
            <a:prstGeom prst="rect">
              <a:avLst/>
            </a:prstGeom>
          </p:spPr>
        </p:pic>
        <p:pic>
          <p:nvPicPr>
            <p:cNvPr id="7" name="Picture 6" descr="A picture containing dark, lit, night sky&#10;&#10;Description automatically generated">
              <a:extLst>
                <a:ext uri="{FF2B5EF4-FFF2-40B4-BE49-F238E27FC236}">
                  <a16:creationId xmlns:a16="http://schemas.microsoft.com/office/drawing/2014/main" id="{8D770FB0-4B09-F29B-BB1B-3C827B15B0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16" t="14749" r="42657" b="43294"/>
            <a:stretch/>
          </p:blipFill>
          <p:spPr>
            <a:xfrm>
              <a:off x="537382" y="1252354"/>
              <a:ext cx="3182822" cy="2453268"/>
            </a:xfrm>
            <a:prstGeom prst="rect">
              <a:avLst/>
            </a:prstGeom>
          </p:spPr>
        </p:pic>
        <p:pic>
          <p:nvPicPr>
            <p:cNvPr id="12" name="Picture 11" descr="A picture containing dark, lit, night sky&#10;&#10;Description automatically generated">
              <a:extLst>
                <a:ext uri="{FF2B5EF4-FFF2-40B4-BE49-F238E27FC236}">
                  <a16:creationId xmlns:a16="http://schemas.microsoft.com/office/drawing/2014/main" id="{B46FCB63-0E28-8A77-433B-BCB9B8150C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81" t="25262" r="49864" b="49382"/>
            <a:stretch/>
          </p:blipFill>
          <p:spPr>
            <a:xfrm>
              <a:off x="3933450" y="1252354"/>
              <a:ext cx="2858045" cy="2453267"/>
            </a:xfrm>
            <a:prstGeom prst="rect">
              <a:avLst/>
            </a:prstGeom>
          </p:spPr>
        </p:pic>
        <p:pic>
          <p:nvPicPr>
            <p:cNvPr id="13" name="Picture 12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id="{F5C60AC2-BBC6-AB1D-E265-95FFD820DA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36" t="30060" r="48807" b="45381"/>
            <a:stretch/>
          </p:blipFill>
          <p:spPr>
            <a:xfrm>
              <a:off x="3919210" y="3813719"/>
              <a:ext cx="2858045" cy="2453268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F983A6A-34F3-69E1-B20B-22F8824E5CE2}"/>
                </a:ext>
              </a:extLst>
            </p:cNvPr>
            <p:cNvSpPr/>
            <p:nvPr/>
          </p:nvSpPr>
          <p:spPr>
            <a:xfrm>
              <a:off x="1416491" y="1788799"/>
              <a:ext cx="1727200" cy="159657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227E9BB8-02E9-77D2-AE92-A3B9AAE1D671}"/>
                </a:ext>
              </a:extLst>
            </p:cNvPr>
            <p:cNvSpPr/>
            <p:nvPr/>
          </p:nvSpPr>
          <p:spPr>
            <a:xfrm>
              <a:off x="1357937" y="4409054"/>
              <a:ext cx="1727200" cy="159657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AAD8E2E6-2A87-F3A1-0009-F69E230AB1EE}"/>
                </a:ext>
              </a:extLst>
            </p:cNvPr>
            <p:cNvCxnSpPr/>
            <p:nvPr/>
          </p:nvCxnSpPr>
          <p:spPr>
            <a:xfrm flipV="1">
              <a:off x="3143691" y="1252354"/>
              <a:ext cx="746491" cy="536445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6DF0C541-B5A4-4DBE-23C9-058C20C900B3}"/>
                </a:ext>
              </a:extLst>
            </p:cNvPr>
            <p:cNvCxnSpPr>
              <a:cxnSpLocks/>
            </p:cNvCxnSpPr>
            <p:nvPr/>
          </p:nvCxnSpPr>
          <p:spPr>
            <a:xfrm>
              <a:off x="3085137" y="5985552"/>
              <a:ext cx="820555" cy="281435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F9939FE-6DC9-9253-5733-9417B294EC48}"/>
                </a:ext>
              </a:extLst>
            </p:cNvPr>
            <p:cNvSpPr/>
            <p:nvPr/>
          </p:nvSpPr>
          <p:spPr>
            <a:xfrm>
              <a:off x="1422754" y="1808976"/>
              <a:ext cx="1727200" cy="159657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F7AF1301-8F21-4307-59C0-133A7ED66C36}"/>
                </a:ext>
              </a:extLst>
            </p:cNvPr>
            <p:cNvCxnSpPr>
              <a:cxnSpLocks/>
            </p:cNvCxnSpPr>
            <p:nvPr/>
          </p:nvCxnSpPr>
          <p:spPr>
            <a:xfrm>
              <a:off x="3139000" y="3365297"/>
              <a:ext cx="766692" cy="349645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B34BDDD0-E3F6-2C0C-7ABA-C52C36B6FCE5}"/>
                </a:ext>
              </a:extLst>
            </p:cNvPr>
            <p:cNvCxnSpPr/>
            <p:nvPr/>
          </p:nvCxnSpPr>
          <p:spPr>
            <a:xfrm flipV="1">
              <a:off x="3103845" y="3866581"/>
              <a:ext cx="746491" cy="536445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54A4CF9A-66E7-E8E8-3148-1CDC38FFFA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51215" y="3272654"/>
              <a:ext cx="355600" cy="20073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AE4EE2BB-D2FF-3067-E1DE-DDAE50E6799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70283" y="1968633"/>
              <a:ext cx="449378" cy="0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06F73473-60BC-0563-C568-DC87B11AA3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550" y="2731804"/>
              <a:ext cx="309354" cy="0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F18F5373-6C7B-11FD-BCB7-C3FBC073C4A9}"/>
                </a:ext>
              </a:extLst>
            </p:cNvPr>
            <p:cNvCxnSpPr>
              <a:cxnSpLocks/>
            </p:cNvCxnSpPr>
            <p:nvPr/>
          </p:nvCxnSpPr>
          <p:spPr>
            <a:xfrm>
              <a:off x="7976519" y="2378513"/>
              <a:ext cx="0" cy="404514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D9A8DFB-900F-2F6C-CF3F-79C8A0B71F45}"/>
                </a:ext>
              </a:extLst>
            </p:cNvPr>
            <p:cNvSpPr txBox="1"/>
            <p:nvPr/>
          </p:nvSpPr>
          <p:spPr>
            <a:xfrm>
              <a:off x="478287" y="944202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  <p:pic>
          <p:nvPicPr>
            <p:cNvPr id="45" name="Picture 44" descr="Green lights in the sky&#10;&#10;Description automatically generated with medium confidence">
              <a:extLst>
                <a:ext uri="{FF2B5EF4-FFF2-40B4-BE49-F238E27FC236}">
                  <a16:creationId xmlns:a16="http://schemas.microsoft.com/office/drawing/2014/main" id="{6B82D76F-B3C5-7077-AB3F-ECCE832AF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28502" y="1292838"/>
              <a:ext cx="4262234" cy="2430956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A487749-3C5F-0DD5-E78C-2EF1D4B7D2C0}"/>
                </a:ext>
              </a:extLst>
            </p:cNvPr>
            <p:cNvSpPr txBox="1"/>
            <p:nvPr/>
          </p:nvSpPr>
          <p:spPr>
            <a:xfrm>
              <a:off x="7313292" y="951588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16533AA-7E2C-0E58-3D55-0D386C61C7A2}"/>
                </a:ext>
              </a:extLst>
            </p:cNvPr>
            <p:cNvSpPr txBox="1"/>
            <p:nvPr/>
          </p:nvSpPr>
          <p:spPr>
            <a:xfrm>
              <a:off x="478287" y="243361"/>
              <a:ext cx="92528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2- FSP1 promoter activity in the mouse aortic valve </a:t>
              </a:r>
            </a:p>
          </p:txBody>
        </p:sp>
        <p:pic>
          <p:nvPicPr>
            <p:cNvPr id="43" name="Picture 42" descr="A picture containing night sky, ocean floor&#10;&#10;Description automatically generated">
              <a:extLst>
                <a:ext uri="{FF2B5EF4-FFF2-40B4-BE49-F238E27FC236}">
                  <a16:creationId xmlns:a16="http://schemas.microsoft.com/office/drawing/2014/main" id="{A805CF54-42F6-0D5A-BBC7-21D7FBFB1E0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28502" y="3851217"/>
              <a:ext cx="4262233" cy="2321018"/>
            </a:xfrm>
            <a:prstGeom prst="rect">
              <a:avLst/>
            </a:prstGeom>
          </p:spPr>
        </p:pic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86668846-737D-EBEE-A40A-F86F4299611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346619" y="2916877"/>
              <a:ext cx="367941" cy="106092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CA6EC70A-0D06-0A23-3F6A-2CD795D791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80745" y="2537043"/>
              <a:ext cx="0" cy="331184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8BD111D2-231B-ACF1-922E-3A285DF779D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24811" y="2580770"/>
              <a:ext cx="276337" cy="389153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559D208D-633F-84D8-2D5F-F052906FF62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06068" y="3431079"/>
              <a:ext cx="355600" cy="20073"/>
            </a:xfrm>
            <a:prstGeom prst="straightConnector1">
              <a:avLst/>
            </a:prstGeom>
            <a:ln w="28575">
              <a:solidFill>
                <a:srgbClr val="FFC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FC4B1DE3-C6DD-C7F8-F6FF-9613FCAA015F}"/>
                </a:ext>
              </a:extLst>
            </p:cNvPr>
            <p:cNvCxnSpPr/>
            <p:nvPr/>
          </p:nvCxnSpPr>
          <p:spPr>
            <a:xfrm>
              <a:off x="7653450" y="3540119"/>
              <a:ext cx="1320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B7082D23-BC0C-4D48-D141-75BC5848F2E6}"/>
                </a:ext>
              </a:extLst>
            </p:cNvPr>
            <p:cNvCxnSpPr/>
            <p:nvPr/>
          </p:nvCxnSpPr>
          <p:spPr>
            <a:xfrm>
              <a:off x="4041672" y="3540119"/>
              <a:ext cx="1320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E35EACB1-C9E8-814D-2841-C61652D45B6F}"/>
                </a:ext>
              </a:extLst>
            </p:cNvPr>
            <p:cNvCxnSpPr/>
            <p:nvPr/>
          </p:nvCxnSpPr>
          <p:spPr>
            <a:xfrm>
              <a:off x="7653450" y="5869662"/>
              <a:ext cx="1320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4963C1E3-CEBE-33E3-BEC6-0E64AE53BA2E}"/>
                </a:ext>
              </a:extLst>
            </p:cNvPr>
            <p:cNvCxnSpPr/>
            <p:nvPr/>
          </p:nvCxnSpPr>
          <p:spPr>
            <a:xfrm>
              <a:off x="4106197" y="6009568"/>
              <a:ext cx="1320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743870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78512" y="443184"/>
            <a:ext cx="6956502" cy="883812"/>
          </a:xfrm>
        </p:spPr>
        <p:txBody>
          <a:bodyPr>
            <a:norm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- H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eart/body ratio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Content Placeholder 5"/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6983534"/>
              </p:ext>
            </p:extLst>
          </p:nvPr>
        </p:nvGraphicFramePr>
        <p:xfrm>
          <a:off x="3200401" y="1524000"/>
          <a:ext cx="5559539" cy="342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744000" imgH="2412000" progId="Prism5.Document">
                  <p:embed/>
                </p:oleObj>
              </mc:Choice>
              <mc:Fallback>
                <p:oleObj name="Prism Project" r:id="rId2" imgW="3744000" imgH="2412000" progId="Prism5.Document">
                  <p:embed/>
                  <p:pic>
                    <p:nvPicPr>
                      <p:cNvPr id="6" name="Content Placeholder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0401" y="1524000"/>
                        <a:ext cx="5559539" cy="3429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6F12787-F9A6-F66B-2041-8ED319909463}"/>
              </a:ext>
            </a:extLst>
          </p:cNvPr>
          <p:cNvSpPr txBox="1"/>
          <p:nvPr/>
        </p:nvSpPr>
        <p:spPr>
          <a:xfrm>
            <a:off x="6239224" y="4651022"/>
            <a:ext cx="217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SP1-cre+/SmoM2+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B4B4EC-287E-8FC9-4902-B15211E0BC19}"/>
              </a:ext>
            </a:extLst>
          </p:cNvPr>
          <p:cNvSpPr txBox="1"/>
          <p:nvPr/>
        </p:nvSpPr>
        <p:spPr>
          <a:xfrm>
            <a:off x="4132429" y="4630715"/>
            <a:ext cx="213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SP1-cre-/SmoM2+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05EE55-FE84-2BAE-A842-B53805D9A18A}"/>
              </a:ext>
            </a:extLst>
          </p:cNvPr>
          <p:cNvSpPr txBox="1"/>
          <p:nvPr/>
        </p:nvSpPr>
        <p:spPr>
          <a:xfrm>
            <a:off x="5740774" y="169333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=0.3</a:t>
            </a:r>
          </a:p>
        </p:txBody>
      </p:sp>
    </p:spTree>
    <p:extLst>
      <p:ext uri="{BB962C8B-B14F-4D97-AF65-F5344CB8AC3E}">
        <p14:creationId xmlns:p14="http://schemas.microsoft.com/office/powerpoint/2010/main" val="13470782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3</Words>
  <Application>Microsoft Macintosh PowerPoint</Application>
  <PresentationFormat>Widescreen</PresentationFormat>
  <Paragraphs>18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 2013 - 2022</vt:lpstr>
      <vt:lpstr>Prism Project</vt:lpstr>
      <vt:lpstr>PowerPoint Presentation</vt:lpstr>
      <vt:lpstr>PowerPoint Presentation</vt:lpstr>
      <vt:lpstr>Supplementary Figure 3- Heart/body ratio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- Heart/body ratio</dc:title>
  <dc:creator>Zhang, Xiaoli</dc:creator>
  <cp:lastModifiedBy>Zhang, Xiaoli</cp:lastModifiedBy>
  <cp:revision>3</cp:revision>
  <dcterms:created xsi:type="dcterms:W3CDTF">2022-12-29T03:25:55Z</dcterms:created>
  <dcterms:modified xsi:type="dcterms:W3CDTF">2022-12-30T01:39:49Z</dcterms:modified>
</cp:coreProperties>
</file>